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242" y="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653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414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561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521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671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945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973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025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055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174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87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79876-B77B-4F52-9C29-DC9A4BDDF278}" type="datetimeFigureOut">
              <a:rPr lang="en-US" smtClean="0"/>
              <a:t>6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822F6-49FA-4CA4-92EB-C6E27C199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193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xmlns="" id="{6430E65D-3CF8-4121-9A58-487F8141A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39189-2BCD-804B-A971-BAAF0A48A5D3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xmlns="" id="{B3D1E09A-DC7C-4CDE-8DB4-F171D3D423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4198031"/>
              </p:ext>
            </p:extLst>
          </p:nvPr>
        </p:nvGraphicFramePr>
        <p:xfrm>
          <a:off x="374903" y="2619122"/>
          <a:ext cx="8394197" cy="1708464"/>
        </p:xfrm>
        <a:graphic>
          <a:graphicData uri="http://schemas.openxmlformats.org/drawingml/2006/table">
            <a:tbl>
              <a:tblPr firstRow="1">
                <a:tableStyleId>{0505E3EF-67EA-436B-97B2-0124C06EBD24}</a:tableStyleId>
              </a:tblPr>
              <a:tblGrid>
                <a:gridCol w="1199171">
                  <a:extLst>
                    <a:ext uri="{9D8B030D-6E8A-4147-A177-3AD203B41FA5}">
                      <a16:colId xmlns:a16="http://schemas.microsoft.com/office/drawing/2014/main" xmlns="" val="316432436"/>
                    </a:ext>
                  </a:extLst>
                </a:gridCol>
                <a:gridCol w="1199171">
                  <a:extLst>
                    <a:ext uri="{9D8B030D-6E8A-4147-A177-3AD203B41FA5}">
                      <a16:colId xmlns:a16="http://schemas.microsoft.com/office/drawing/2014/main" xmlns="" val="326748306"/>
                    </a:ext>
                  </a:extLst>
                </a:gridCol>
                <a:gridCol w="1199171">
                  <a:extLst>
                    <a:ext uri="{9D8B030D-6E8A-4147-A177-3AD203B41FA5}">
                      <a16:colId xmlns:a16="http://schemas.microsoft.com/office/drawing/2014/main" xmlns="" val="1917298329"/>
                    </a:ext>
                  </a:extLst>
                </a:gridCol>
                <a:gridCol w="119917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9917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9917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9917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1112401"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Drug</a:t>
                      </a: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ell line</a:t>
                      </a: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Point (h)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50 (µM) ±</a:t>
                      </a:r>
                      <a:r>
                        <a:rPr lang="en-US" sz="1400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d. Error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228600" marR="0" indent="-22860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ll Coefficient±</a:t>
                      </a:r>
                      <a:r>
                        <a:rPr lang="en-US" sz="1400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d. Error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.x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81644">
                <a:tc>
                  <a:txBody>
                    <a:bodyPr/>
                    <a:lstStyle/>
                    <a:p>
                      <a:pPr marL="228600" marR="0" indent="-22860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37-mer peptide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HeLa</a:t>
                      </a: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marL="228600" marR="0" indent="-22860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24 h</a:t>
                      </a:r>
                    </a:p>
                  </a:txBody>
                  <a:tcPr marL="51435" marR="5143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2.1</a:t>
                      </a:r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412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sz="1400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324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44" marR="7144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</a:t>
                      </a:r>
                    </a:p>
                  </a:txBody>
                  <a:tcPr marL="68580" marR="6858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51</a:t>
                      </a:r>
                    </a:p>
                  </a:txBody>
                  <a:tcPr marL="68580" marR="68580"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29D74EB4-B466-4911-A77D-10840A3C039F}"/>
              </a:ext>
            </a:extLst>
          </p:cNvPr>
          <p:cNvSpPr txBox="1"/>
          <p:nvPr/>
        </p:nvSpPr>
        <p:spPr>
          <a:xfrm>
            <a:off x="70982" y="1676400"/>
            <a:ext cx="94422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Table S2. Summary of IC50, hill coefficient and R2 values obtained for peptide treatment of HeLa and MCF7 cell lin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45449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i</dc:creator>
  <cp:lastModifiedBy>Sheri</cp:lastModifiedBy>
  <cp:revision>2</cp:revision>
  <dcterms:created xsi:type="dcterms:W3CDTF">2023-01-10T10:32:33Z</dcterms:created>
  <dcterms:modified xsi:type="dcterms:W3CDTF">2023-06-29T16:33:25Z</dcterms:modified>
</cp:coreProperties>
</file>